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10.png" ContentType="image/png"/>
  <Override PartName="/ppt/media/image5.wmf" ContentType="image/x-wmf"/>
  <Override PartName="/ppt/media/image11.png" ContentType="image/png"/>
  <Override PartName="/ppt/media/image6.wmf" ContentType="image/x-wmf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95280" y="389160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56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1984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4404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9528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1984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4404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subTitle"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2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ubTitle"/>
          </p:nvPr>
        </p:nvSpPr>
        <p:spPr>
          <a:xfrm>
            <a:off x="250560" y="115560"/>
            <a:ext cx="8435880" cy="300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2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2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6756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395280" y="389160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46756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321984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6044040" y="148428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39528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/>
          </p:nvPr>
        </p:nvSpPr>
        <p:spPr>
          <a:xfrm>
            <a:off x="321984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82" name="PlaceHolder 7"/>
          <p:cNvSpPr>
            <a:spLocks noGrp="1"/>
          </p:cNvSpPr>
          <p:nvPr>
            <p:ph/>
          </p:nvPr>
        </p:nvSpPr>
        <p:spPr>
          <a:xfrm>
            <a:off x="6044040" y="3891600"/>
            <a:ext cx="268956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0560" y="115560"/>
            <a:ext cx="8435880" cy="300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2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5680" y="389160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952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5680" y="1484280"/>
            <a:ext cx="40762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95280" y="3891600"/>
            <a:ext cx="835344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2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Rechthoek 6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0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body"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solidFill>
            <a:srgbClr val="000080"/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57200" indent="-457200">
              <a:spcBef>
                <a:spcPts val="2251"/>
              </a:spcBef>
              <a:buClr>
                <a:srgbClr val="ffff33"/>
              </a:buClr>
              <a:buFont typeface="Lucida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Click to edit the outline text format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1" marL="914400" indent="-457200">
              <a:spcBef>
                <a:spcPts val="2251"/>
              </a:spcBef>
              <a:buClr>
                <a:srgbClr val="ffff33"/>
              </a:buClr>
              <a:buFont typeface="Lucida San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econd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2" marL="1333440" indent="-419040">
              <a:spcBef>
                <a:spcPts val="2251"/>
              </a:spcBef>
              <a:buClr>
                <a:srgbClr val="ffff33"/>
              </a:buClr>
              <a:buFont typeface="Lucida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Third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3" marL="1752480" indent="-380880">
              <a:spcBef>
                <a:spcPts val="2251"/>
              </a:spcBef>
              <a:buClr>
                <a:srgbClr val="ffff33"/>
              </a:buClr>
              <a:buFont typeface="Lucida San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Four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4" marL="2171880" indent="-343080">
              <a:spcBef>
                <a:spcPts val="2251"/>
              </a:spcBef>
              <a:buClr>
                <a:srgbClr val="ffff33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Fif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5" marL="2171880" indent="-343080">
              <a:spcBef>
                <a:spcPts val="2251"/>
              </a:spcBef>
              <a:buClr>
                <a:srgbClr val="000000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ix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6" marL="2171880" indent="-343080">
              <a:spcBef>
                <a:spcPts val="2251"/>
              </a:spcBef>
              <a:buClr>
                <a:srgbClr val="000000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even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2" name="Rectangle 3"/>
          <p:cNvSpPr/>
          <p:nvPr/>
        </p:nvSpPr>
        <p:spPr>
          <a:xfrm>
            <a:off x="0" y="0"/>
            <a:ext cx="9144000" cy="907920"/>
          </a:xfrm>
          <a:prstGeom prst="rect">
            <a:avLst/>
          </a:prstGeom>
          <a:solidFill>
            <a:srgbClr val="ff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80"/>
                </a:solidFill>
                <a:latin typeface="Lucida Sans"/>
              </a:rPr>
              <a:t>Click to edit the title text format</a:t>
            </a: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4" name="Text Box 6"/>
          <p:cNvSpPr/>
          <p:nvPr/>
        </p:nvSpPr>
        <p:spPr>
          <a:xfrm>
            <a:off x="179280" y="765000"/>
            <a:ext cx="84963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hoek 6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0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0" y="0"/>
            <a:ext cx="9144000" cy="907920"/>
          </a:xfrm>
          <a:prstGeom prst="rect">
            <a:avLst/>
          </a:prstGeom>
          <a:solidFill>
            <a:srgbClr val="ff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179280" y="765000"/>
            <a:ext cx="84963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670572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body"/>
          </p:nvPr>
        </p:nvSpPr>
        <p:spPr>
          <a:xfrm>
            <a:off x="395280" y="1484280"/>
            <a:ext cx="8353440" cy="4608720"/>
          </a:xfrm>
          <a:prstGeom prst="rect">
            <a:avLst/>
          </a:prstGeom>
          <a:solidFill>
            <a:srgbClr val="000080"/>
          </a:solidFill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57200" indent="-457200">
              <a:spcBef>
                <a:spcPts val="2251"/>
              </a:spcBef>
              <a:buClr>
                <a:srgbClr val="ffff33"/>
              </a:buClr>
              <a:buFont typeface="Lucida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Click to edit the outline text format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1" marL="914400" indent="-457200">
              <a:spcBef>
                <a:spcPts val="2251"/>
              </a:spcBef>
              <a:buClr>
                <a:srgbClr val="ffff33"/>
              </a:buClr>
              <a:buFont typeface="Lucida San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econd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2" marL="1333440" indent="-419040">
              <a:spcBef>
                <a:spcPts val="2251"/>
              </a:spcBef>
              <a:buClr>
                <a:srgbClr val="ffff33"/>
              </a:buClr>
              <a:buFont typeface="Lucida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Third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3" marL="1752480" indent="-380880">
              <a:spcBef>
                <a:spcPts val="2251"/>
              </a:spcBef>
              <a:buClr>
                <a:srgbClr val="ffff33"/>
              </a:buClr>
              <a:buFont typeface="Lucida San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Four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4" marL="2171880" indent="-343080">
              <a:spcBef>
                <a:spcPts val="2251"/>
              </a:spcBef>
              <a:buClr>
                <a:srgbClr val="ffff33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Fif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5" marL="2171880" indent="-343080">
              <a:spcBef>
                <a:spcPts val="2251"/>
              </a:spcBef>
              <a:buClr>
                <a:srgbClr val="000000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ix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  <a:p>
            <a:pPr lvl="6" marL="2171880" indent="-343080">
              <a:spcBef>
                <a:spcPts val="2251"/>
              </a:spcBef>
              <a:buClr>
                <a:srgbClr val="000000"/>
              </a:buClr>
              <a:buFont typeface="Lucida San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33"/>
                </a:solidFill>
                <a:latin typeface="Lucida Sans"/>
              </a:rPr>
              <a:t>Seventh Outline Level</a:t>
            </a:r>
            <a:endParaRPr b="0" lang="en-US" sz="2400" spc="-1" strike="noStrike">
              <a:solidFill>
                <a:srgbClr val="ffff33"/>
              </a:solidFill>
              <a:latin typeface="Lucida Sans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80"/>
                </a:solidFill>
                <a:latin typeface="Lucida Sans"/>
              </a:rPr>
              <a:t>Click to edit the title text format</a:t>
            </a: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hyperlink" Target="http://www.ikherstel.nl/" TargetMode="External"/><Relationship Id="rId3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wmf"/><Relationship Id="rId3" Type="http://schemas.openxmlformats.org/officeDocument/2006/relationships/image" Target="../media/image5.wmf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5.wmf"/><Relationship Id="rId3" Type="http://schemas.openxmlformats.org/officeDocument/2006/relationships/image" Target="../media/image6.wmf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2" descr="website"/>
          <p:cNvPicPr/>
          <p:nvPr/>
        </p:nvPicPr>
        <p:blipFill>
          <a:blip r:embed="rId1"/>
          <a:stretch/>
        </p:blipFill>
        <p:spPr>
          <a:xfrm>
            <a:off x="0" y="907920"/>
            <a:ext cx="9144000" cy="5977080"/>
          </a:xfrm>
          <a:prstGeom prst="rect">
            <a:avLst/>
          </a:prstGeom>
          <a:ln w="0">
            <a:noFill/>
          </a:ln>
        </p:spPr>
      </p:pic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 u="sng">
                <a:solidFill>
                  <a:srgbClr val="009999"/>
                </a:solidFill>
                <a:uFillTx/>
                <a:latin typeface="Lucida Sans"/>
                <a:hlinkClick r:id="rId2"/>
              </a:rPr>
              <a:t>www.ikherstel.nl</a:t>
            </a: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sp>
        <p:nvSpPr>
          <p:cNvPr id="85" name="TextBox 3"/>
          <p:cNvSpPr/>
          <p:nvPr/>
        </p:nvSpPr>
        <p:spPr>
          <a:xfrm>
            <a:off x="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4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43600"/>
          </a:xfrm>
          <a:prstGeom prst="rect">
            <a:avLst/>
          </a:prstGeom>
          <a:ln w="0">
            <a:noFill/>
          </a:ln>
        </p:spPr>
      </p:pic>
      <p:sp>
        <p:nvSpPr>
          <p:cNvPr id="87" name="TextBox 2"/>
          <p:cNvSpPr/>
          <p:nvPr/>
        </p:nvSpPr>
        <p:spPr>
          <a:xfrm>
            <a:off x="670572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33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Picture 2" descr=""/>
          <p:cNvPicPr/>
          <p:nvPr/>
        </p:nvPicPr>
        <p:blipFill>
          <a:blip r:embed="rId1"/>
          <a:stretch/>
        </p:blipFill>
        <p:spPr>
          <a:xfrm>
            <a:off x="108000" y="1735200"/>
            <a:ext cx="8964720" cy="4718160"/>
          </a:xfrm>
          <a:prstGeom prst="rect">
            <a:avLst/>
          </a:prstGeom>
          <a:ln w="0">
            <a:noFill/>
          </a:ln>
        </p:spPr>
      </p:pic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800" spc="-1" strike="noStrike">
                <a:solidFill>
                  <a:srgbClr val="000080"/>
                </a:solidFill>
                <a:latin typeface="Lucida Sans"/>
              </a:rPr>
              <a:t>Convalescence Plan (I)</a:t>
            </a: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pic>
        <p:nvPicPr>
          <p:cNvPr id="90" name="Picture 4" descr=""/>
          <p:cNvPicPr/>
          <p:nvPr/>
        </p:nvPicPr>
        <p:blipFill>
          <a:blip r:embed="rId2"/>
          <a:stretch/>
        </p:blipFill>
        <p:spPr>
          <a:xfrm>
            <a:off x="34920" y="981000"/>
            <a:ext cx="5851440" cy="22392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5" descr=""/>
          <p:cNvPicPr/>
          <p:nvPr/>
        </p:nvPicPr>
        <p:blipFill>
          <a:blip r:embed="rId3"/>
          <a:stretch/>
        </p:blipFill>
        <p:spPr>
          <a:xfrm>
            <a:off x="5950080" y="981000"/>
            <a:ext cx="3159000" cy="225360"/>
          </a:xfrm>
          <a:prstGeom prst="rect">
            <a:avLst/>
          </a:prstGeom>
          <a:ln w="0">
            <a:noFill/>
          </a:ln>
        </p:spPr>
      </p:pic>
      <p:sp>
        <p:nvSpPr>
          <p:cNvPr id="92" name="TextBox 5"/>
          <p:cNvSpPr/>
          <p:nvPr/>
        </p:nvSpPr>
        <p:spPr>
          <a:xfrm>
            <a:off x="670572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250560" y="115560"/>
            <a:ext cx="8435880" cy="647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800" spc="-1" strike="noStrike">
                <a:solidFill>
                  <a:srgbClr val="000080"/>
                </a:solidFill>
                <a:latin typeface="Lucida Sans"/>
              </a:rPr>
              <a:t>Convalescence Plan (II)</a:t>
            </a:r>
            <a:endParaRPr b="1" lang="en-US" sz="2800" spc="-1" strike="noStrike">
              <a:solidFill>
                <a:srgbClr val="000080"/>
              </a:solidFill>
              <a:latin typeface="Lucida Sans"/>
            </a:endParaRPr>
          </a:p>
        </p:txBody>
      </p:sp>
      <p:pic>
        <p:nvPicPr>
          <p:cNvPr id="94" name="Picture 4" descr=""/>
          <p:cNvPicPr/>
          <p:nvPr/>
        </p:nvPicPr>
        <p:blipFill>
          <a:blip r:embed="rId1"/>
          <a:stretch/>
        </p:blipFill>
        <p:spPr>
          <a:xfrm>
            <a:off x="34920" y="981000"/>
            <a:ext cx="5851440" cy="22392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5" descr=""/>
          <p:cNvPicPr/>
          <p:nvPr/>
        </p:nvPicPr>
        <p:blipFill>
          <a:blip r:embed="rId2"/>
          <a:stretch/>
        </p:blipFill>
        <p:spPr>
          <a:xfrm>
            <a:off x="5950080" y="981000"/>
            <a:ext cx="3159000" cy="22536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6" descr=""/>
          <p:cNvPicPr/>
          <p:nvPr/>
        </p:nvPicPr>
        <p:blipFill>
          <a:blip r:embed="rId3"/>
          <a:stretch/>
        </p:blipFill>
        <p:spPr>
          <a:xfrm>
            <a:off x="844560" y="1249200"/>
            <a:ext cx="7537320" cy="5303880"/>
          </a:xfrm>
          <a:prstGeom prst="rect">
            <a:avLst/>
          </a:prstGeom>
          <a:ln w="0">
            <a:noFill/>
          </a:ln>
        </p:spPr>
      </p:pic>
      <p:sp>
        <p:nvSpPr>
          <p:cNvPr id="97" name="TextBox 5"/>
          <p:cNvSpPr/>
          <p:nvPr/>
        </p:nvSpPr>
        <p:spPr>
          <a:xfrm>
            <a:off x="670572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Picture 2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99" name="TextBox 3"/>
          <p:cNvSpPr/>
          <p:nvPr/>
        </p:nvSpPr>
        <p:spPr>
          <a:xfrm>
            <a:off x="6705720" y="655020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pyright © 2009: ikherstel.nl</a:t>
            </a:r>
            <a:endParaRPr b="0" lang="en-US" sz="14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>
            <a:alpha val="0"/>
          </a:srgbClr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Group 21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101" name="Picture 19" descr=""/>
            <p:cNvPicPr/>
            <p:nvPr/>
          </p:nvPicPr>
          <p:blipFill>
            <a:blip r:embed="rId1"/>
            <a:stretch/>
          </p:blipFill>
          <p:spPr>
            <a:xfrm>
              <a:off x="0" y="3962520"/>
              <a:ext cx="9144000" cy="2895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3" descr=""/>
            <p:cNvPicPr/>
            <p:nvPr/>
          </p:nvPicPr>
          <p:blipFill>
            <a:blip r:embed="rId2"/>
            <a:stretch/>
          </p:blipFill>
          <p:spPr>
            <a:xfrm>
              <a:off x="3505320" y="4038480"/>
              <a:ext cx="2585520" cy="2514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7" descr=""/>
            <p:cNvPicPr/>
            <p:nvPr/>
          </p:nvPicPr>
          <p:blipFill>
            <a:blip r:embed="rId3"/>
            <a:stretch/>
          </p:blipFill>
          <p:spPr>
            <a:xfrm>
              <a:off x="4191120" y="4953240"/>
              <a:ext cx="1438200" cy="54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15" descr=""/>
            <p:cNvPicPr/>
            <p:nvPr/>
          </p:nvPicPr>
          <p:blipFill>
            <a:blip r:embed="rId4"/>
            <a:stretch/>
          </p:blipFill>
          <p:spPr>
            <a:xfrm>
              <a:off x="0" y="0"/>
              <a:ext cx="9144000" cy="216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Picture 17" descr=""/>
            <p:cNvPicPr/>
            <p:nvPr/>
          </p:nvPicPr>
          <p:blipFill>
            <a:blip r:embed="rId5"/>
            <a:stretch/>
          </p:blipFill>
          <p:spPr>
            <a:xfrm>
              <a:off x="0" y="2133360"/>
              <a:ext cx="9144000" cy="190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TextBox 20"/>
            <p:cNvSpPr/>
            <p:nvPr/>
          </p:nvSpPr>
          <p:spPr>
            <a:xfrm>
              <a:off x="6705720" y="6550560"/>
              <a:ext cx="2438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pyright © 2009: ikherstel.nl</a:t>
              </a:r>
              <a:endParaRPr b="0" lang="en-US" sz="1400" spc="-1" strike="noStrike">
                <a:solidFill>
                  <a:srgbClr val="000000"/>
                </a:solidFill>
                <a:latin typeface="Verdana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2-01T07:49:21Z</dcterms:created>
  <dc:creator>Evert Verhagen</dc:creator>
  <dc:description/>
  <dc:language>en-US</dc:language>
  <cp:lastModifiedBy>Bouwsma, Eva</cp:lastModifiedBy>
  <dcterms:modified xsi:type="dcterms:W3CDTF">2014-03-03T14:55:01Z</dcterms:modified>
  <cp:revision>306</cp:revision>
  <dc:subject/>
  <dc:title>PowerPoint Presentation</dc:title>
</cp:coreProperties>
</file>